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2" r:id="rId2"/>
    <p:sldId id="323" r:id="rId3"/>
    <p:sldId id="257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324" r:id="rId32"/>
    <p:sldId id="32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8" r:id="rId44"/>
    <p:sldId id="299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  <p:sldId id="310" r:id="rId56"/>
    <p:sldId id="311" r:id="rId57"/>
    <p:sldId id="312" r:id="rId58"/>
    <p:sldId id="313" r:id="rId59"/>
    <p:sldId id="314" r:id="rId60"/>
    <p:sldId id="315" r:id="rId61"/>
    <p:sldId id="316" r:id="rId62"/>
    <p:sldId id="317" r:id="rId63"/>
    <p:sldId id="318" r:id="rId64"/>
    <p:sldId id="319" r:id="rId65"/>
    <p:sldId id="320" r:id="rId66"/>
    <p:sldId id="321" r:id="rId6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84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4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presProps" Target="presProps.xml"/><Relationship Id="rId7" Type="http://schemas.openxmlformats.org/officeDocument/2006/relationships/slide" Target="slides/slide6.xml"/><Relationship Id="rId71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viewProps" Target="view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5667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053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0545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5402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4774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5919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7375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245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3846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9904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1541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871583-BD5A-4230-A74E-979B0E4F23B4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6ECB2-1788-4555-807C-34FCECF9F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3855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615440" y="2136516"/>
            <a:ext cx="9144000" cy="2387600"/>
          </a:xfrm>
        </p:spPr>
        <p:txBody>
          <a:bodyPr>
            <a:noAutofit/>
          </a:bodyPr>
          <a:lstStyle/>
          <a:p>
            <a:r>
              <a:rPr lang="en-GB" altLang="ko-KR" sz="4400" dirty="0">
                <a:solidFill>
                  <a:srgbClr val="000000"/>
                </a:solidFill>
                <a:latin typeface="Times New Roman" panose="02020603050405020304" pitchFamily="18" charset="0"/>
              </a:rPr>
              <a:t>Kaplan-Meier </a:t>
            </a:r>
            <a:r>
              <a:rPr lang="en-GB" altLang="ko-KR" sz="4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urves Comparing All-cause Mortalities </a:t>
            </a:r>
            <a:r>
              <a:rPr lang="en-GB" altLang="ko-KR" sz="4400" dirty="0">
                <a:solidFill>
                  <a:srgbClr val="000000"/>
                </a:solidFill>
                <a:latin typeface="Times New Roman" panose="02020603050405020304" pitchFamily="18" charset="0"/>
              </a:rPr>
              <a:t>in Entire Cohort </a:t>
            </a:r>
            <a:r>
              <a:rPr lang="en-GB" altLang="ko-KR" sz="4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According </a:t>
            </a:r>
            <a:r>
              <a:rPr lang="en-GB" altLang="ko-KR" sz="4400" dirty="0">
                <a:solidFill>
                  <a:srgbClr val="000000"/>
                </a:solidFill>
                <a:latin typeface="Times New Roman" panose="02020603050405020304" pitchFamily="18" charset="0"/>
              </a:rPr>
              <a:t>to </a:t>
            </a:r>
            <a:r>
              <a:rPr lang="en-GB" altLang="ko-KR" sz="4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omorbidities </a:t>
            </a:r>
            <a:r>
              <a:rPr lang="en-GB" altLang="ko-KR" sz="4400" dirty="0">
                <a:solidFill>
                  <a:srgbClr val="000000"/>
                </a:solidFill>
                <a:latin typeface="Times New Roman" panose="02020603050405020304" pitchFamily="18" charset="0"/>
              </a:rPr>
              <a:t>and </a:t>
            </a:r>
            <a:r>
              <a:rPr lang="en-GB" altLang="ko-KR" sz="4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linical Variables</a:t>
            </a:r>
            <a:endParaRPr lang="ko-KR" altLang="en-US" sz="4400" dirty="0"/>
          </a:p>
        </p:txBody>
      </p:sp>
    </p:spTree>
    <p:extLst>
      <p:ext uri="{BB962C8B-B14F-4D97-AF65-F5344CB8AC3E}">
        <p14:creationId xmlns:p14="http://schemas.microsoft.com/office/powerpoint/2010/main" val="2015447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2718" y="965200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57275" y="1781175"/>
            <a:ext cx="1833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8. Use of LA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033052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2159" y="725583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14425" y="1695450"/>
            <a:ext cx="1836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9. Hypertensio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172656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3492" y="818767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66800" y="1400175"/>
            <a:ext cx="22100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0. Ischemic Heart </a:t>
            </a:r>
          </a:p>
          <a:p>
            <a:r>
              <a:rPr lang="en-US" altLang="ko-KR" dirty="0" smtClean="0"/>
              <a:t>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72254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0581" y="777569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00150" y="2028825"/>
            <a:ext cx="1727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1. Arrhyth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40885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5859" y="657072"/>
            <a:ext cx="7921760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43000" y="1819275"/>
            <a:ext cx="1873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2. Heart failur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73209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4450" y="70802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09600" y="1762125"/>
            <a:ext cx="3092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3. Cerebro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25070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7943" y="685800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8625" y="2047875"/>
            <a:ext cx="335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4. Peripheral 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01695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2675" y="758825"/>
            <a:ext cx="7921760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90625" y="1409700"/>
            <a:ext cx="135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5. Asth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2162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5650" y="58737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33425" y="1590675"/>
            <a:ext cx="2040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6. Bronchiecta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7911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3100" y="730250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52575" y="1333500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7. DM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272786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939973"/>
          </a:xfrm>
        </p:spPr>
        <p:txBody>
          <a:bodyPr>
            <a:normAutofit/>
          </a:bodyPr>
          <a:lstStyle/>
          <a:p>
            <a:r>
              <a:rPr lang="en-GB" altLang="ko-KR" sz="24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List of Comorbidities </a:t>
            </a:r>
            <a:r>
              <a:rPr lang="en-GB" altLang="ko-KR" sz="2400" dirty="0">
                <a:solidFill>
                  <a:srgbClr val="000000"/>
                </a:solidFill>
                <a:latin typeface="Times New Roman" panose="02020603050405020304" pitchFamily="18" charset="0"/>
              </a:rPr>
              <a:t>and Clinical Variables</a:t>
            </a:r>
            <a:endParaRPr lang="ko-KR" altLang="en-US" sz="2400" dirty="0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513235"/>
            <a:ext cx="4540135" cy="4351338"/>
          </a:xfrm>
        </p:spPr>
        <p:txBody>
          <a:bodyPr>
            <a:noAutofit/>
          </a:bodyPr>
          <a:lstStyle/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group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 insurance type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ylxanthines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Systemic beta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nosit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Inhaled corticosteroid (ICS)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beta-2 agonist (LABA)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muscarinic antagonist (LAMA)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emic heart disease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ac arrhythmia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rt failure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rebrovascular disease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pheral vascular disease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내용 개체 틀 4"/>
          <p:cNvSpPr>
            <a:spLocks noGrp="1"/>
          </p:cNvSpPr>
          <p:nvPr>
            <p:ph sz="half" idx="2"/>
          </p:nvPr>
        </p:nvSpPr>
        <p:spPr>
          <a:xfrm>
            <a:off x="5881254" y="1513235"/>
            <a:ext cx="5232862" cy="4596620"/>
          </a:xfrm>
        </p:spPr>
        <p:txBody>
          <a:bodyPr vert="horz" lIns="91440" tIns="45720" rIns="91440" bIns="45720" rtlCol="0">
            <a:noAutofit/>
          </a:bodyPr>
          <a:lstStyle/>
          <a:p>
            <a:pPr marL="0" lvl="0" indent="0">
              <a:buNone/>
            </a:pP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. Asthma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lv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. Bronchiectasis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lv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. Diabetes mellitus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 Dyslipidemia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. Chronic kidney disease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. Osteoporosis 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. Gastroesophageal reflux disease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. Chronic liver disease such as liver cirrhosis or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tty liver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. Malignancy 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. Lung cancer 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. Stomach cancer 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. Colorectal cancer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. Liver cancer</a:t>
            </a:r>
          </a:p>
          <a:p>
            <a:pPr marL="0" indent="0">
              <a:buNone/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. Thyroid cancer</a:t>
            </a:r>
          </a:p>
          <a:p>
            <a:pPr marL="514350" indent="-514350">
              <a:lnSpc>
                <a:spcPct val="100000"/>
              </a:lnSpc>
              <a:buFont typeface="+mj-lt"/>
              <a:buAutoNum type="arabicPeriod" startAt="18"/>
            </a:pPr>
            <a:endParaRPr lang="en-US" altLang="ko-KR" sz="1200" dirty="0"/>
          </a:p>
          <a:p>
            <a:pPr marL="514350" indent="-514350">
              <a:lnSpc>
                <a:spcPct val="100000"/>
              </a:lnSpc>
              <a:buFont typeface="+mj-lt"/>
              <a:buAutoNum type="arabicPeriod" startAt="18"/>
            </a:pPr>
            <a:endParaRPr lang="ko-KR" altLang="en-US" sz="1200" dirty="0"/>
          </a:p>
          <a:p>
            <a:pPr marL="514350" indent="-514350">
              <a:lnSpc>
                <a:spcPct val="100000"/>
              </a:lnSpc>
              <a:buFont typeface="+mj-lt"/>
              <a:buAutoNum type="arabicPeriod" startAt="18"/>
            </a:pP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77970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9555" y="68262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52500" y="2600325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8. Dyslipide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00447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6300" y="892175"/>
            <a:ext cx="7921760" cy="540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05592" y="2200038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9. CK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01165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7250" y="774700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66800" y="1704975"/>
            <a:ext cx="1934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0. Osteoporo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161429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5800" y="57467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38275" y="1771650"/>
            <a:ext cx="1157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1. GER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67016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8400" y="60642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19150" y="2038350"/>
            <a:ext cx="2717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2. Chronic live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46811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7050" y="71437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0" y="1676400"/>
            <a:ext cx="1763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3. Malignancy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44657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9475" y="819150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23950" y="1838325"/>
            <a:ext cx="1845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4. Lung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32907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6950" y="98107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33450" y="1781175"/>
            <a:ext cx="22281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5. Stomach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2595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4100" y="84772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19175" y="2000250"/>
            <a:ext cx="2374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6. Colorectal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71717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3600" y="60007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71600" y="1504950"/>
            <a:ext cx="1811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7. Liver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6723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3027" y="700881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33500" y="135255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. Sex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94959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2175" y="549276"/>
            <a:ext cx="7200000" cy="55467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00125" y="1504950"/>
            <a:ext cx="2111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8. Thyroid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97712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440873" y="2111577"/>
            <a:ext cx="9144000" cy="2387600"/>
          </a:xfrm>
        </p:spPr>
        <p:txBody>
          <a:bodyPr>
            <a:normAutofit/>
          </a:bodyPr>
          <a:lstStyle/>
          <a:p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Kaplan-Meier Curves </a:t>
            </a:r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Comparing All-cause Mortalities in </a:t>
            </a: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Health-screening Cohort </a:t>
            </a:r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According to Comorbidities and </a:t>
            </a: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/>
            </a:r>
            <a:b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</a:b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linical Variables</a:t>
            </a:r>
            <a:endParaRPr lang="ko-KR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19587864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8199" y="365126"/>
            <a:ext cx="6693131" cy="839832"/>
          </a:xfrm>
        </p:spPr>
        <p:txBody>
          <a:bodyPr>
            <a:normAutofit/>
          </a:bodyPr>
          <a:lstStyle/>
          <a:p>
            <a:r>
              <a:rPr lang="en-GB" altLang="ko-KR" sz="2400" dirty="0">
                <a:solidFill>
                  <a:srgbClr val="000000"/>
                </a:solidFill>
                <a:latin typeface="Times New Roman" panose="02020603050405020304" pitchFamily="18" charset="0"/>
              </a:rPr>
              <a:t>List of Comorbidities and Clinical Variables</a:t>
            </a:r>
            <a:endParaRPr lang="ko-KR" altLang="en-US" sz="2400" dirty="0"/>
          </a:p>
        </p:txBody>
      </p:sp>
      <p:sp>
        <p:nvSpPr>
          <p:cNvPr id="4" name="내용 개체 틀 3"/>
          <p:cNvSpPr>
            <a:spLocks noGrp="1"/>
          </p:cNvSpPr>
          <p:nvPr>
            <p:ph sz="half" idx="1"/>
          </p:nvPr>
        </p:nvSpPr>
        <p:spPr>
          <a:xfrm>
            <a:off x="990600" y="1288302"/>
            <a:ext cx="5181600" cy="4896585"/>
          </a:xfrm>
        </p:spPr>
        <p:txBody>
          <a:bodyPr>
            <a:normAutofit fontScale="40000" lnSpcReduction="20000"/>
          </a:bodyPr>
          <a:lstStyle/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group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 insurance type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</a:t>
            </a:r>
            <a:r>
              <a:rPr lang="en-US" altLang="ko-KR" sz="3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ylxanthines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Systemic beta </a:t>
            </a:r>
            <a:r>
              <a:rPr lang="en-US" altLang="ko-KR" sz="3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nosit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Inhaled corticosteroid (ICS)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beta-2 agonist (LABA)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muscarinic antagonist (LAMA)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emic heart diseas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ac arrhythmia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rt failur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rebrovascular diseas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pheral vascular diseas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hma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onchiectasis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mellitus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ko-KR" altLang="en-US" dirty="0"/>
          </a:p>
        </p:txBody>
      </p:sp>
      <p:sp>
        <p:nvSpPr>
          <p:cNvPr id="6" name="내용 개체 틀 5"/>
          <p:cNvSpPr>
            <a:spLocks noGrp="1"/>
          </p:cNvSpPr>
          <p:nvPr>
            <p:ph sz="half" idx="2"/>
          </p:nvPr>
        </p:nvSpPr>
        <p:spPr>
          <a:xfrm>
            <a:off x="6172200" y="1288302"/>
            <a:ext cx="5181600" cy="4972006"/>
          </a:xfrm>
        </p:spPr>
        <p:txBody>
          <a:bodyPr>
            <a:normAutofit fontScale="40000" lnSpcReduction="20000"/>
          </a:bodyPr>
          <a:lstStyle/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. Dyslipidemia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. Chronic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 </a:t>
            </a: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. Osteoporosis 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. Gastroesophageal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lux diseas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. Chronic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disease such as liver cirrhosis or fatty liver disease 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. Malignancy 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. Lung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. Stomach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. Colorectal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. Liver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. Thyroid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. BMI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. Hemoglobin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. Fasting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glucos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. Total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lesterol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. Serum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atinin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. Smoking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us</a:t>
            </a:r>
          </a:p>
          <a:p>
            <a:pPr marL="0" indent="0">
              <a:buNone/>
            </a:pP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44385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956050" y="792162"/>
            <a:ext cx="720000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14500" y="145732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. Sex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44126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5051" y="6143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47800" y="1771650"/>
            <a:ext cx="15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. Age group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43964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1284" y="7000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38200" y="1885950"/>
            <a:ext cx="2767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. Health Insurance Typ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5875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4701" y="7159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28675" y="1447800"/>
            <a:ext cx="2048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4. </a:t>
            </a:r>
            <a:r>
              <a:rPr lang="en-US" altLang="ko-KR" dirty="0" err="1" smtClean="0"/>
              <a:t>Methylxanthin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169706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3501" y="51911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95350" y="1381125"/>
            <a:ext cx="2738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5. Systemic beta agonist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85856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8976" y="6810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6325" y="1476375"/>
            <a:ext cx="153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6. Use of IC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65015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1376" y="5381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90600" y="1238250"/>
            <a:ext cx="1756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7. Use of LAB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24808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8551" y="509492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62100" y="1295400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. Ag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22166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2326" y="9096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33475" y="1809750"/>
            <a:ext cx="1833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8. Use of LA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13805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8076" y="871537"/>
            <a:ext cx="7841455" cy="540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47775" y="1781175"/>
            <a:ext cx="1836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9. Hypertensio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69595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9856" y="8651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2000" y="1743075"/>
            <a:ext cx="29378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0. Ischemic heart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18951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1" y="846137"/>
            <a:ext cx="7841455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00125" y="1554481"/>
            <a:ext cx="1727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1. Arrhyth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64082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8501" y="5857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85850" y="1495425"/>
            <a:ext cx="1873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2. Heart failur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153608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7601" y="8524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64895" y="1866900"/>
            <a:ext cx="3092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3. Cerebro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96341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4301" y="8143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00050" y="1781175"/>
            <a:ext cx="335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4. Peripheral 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950865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4226" y="576262"/>
            <a:ext cx="7841455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19200" y="1990725"/>
            <a:ext cx="135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5. Asth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09098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251" y="7286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85850" y="1457325"/>
            <a:ext cx="2040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6. Bronchiecta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0334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2301" y="7667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90675" y="1647825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7. DM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389531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9834" y="619142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57250" y="1590675"/>
            <a:ext cx="2767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. Health Insurance Typ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67361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5651" y="8207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6325" y="1619250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8. Dyslipide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318658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1826" y="78581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6325" y="1278256"/>
            <a:ext cx="104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ko-KR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771650" y="109359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9. CK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92475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5176" y="7762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76300" y="1466850"/>
            <a:ext cx="1934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2</a:t>
            </a:r>
            <a:r>
              <a:rPr lang="en-US" altLang="ko-KR" dirty="0" smtClean="0"/>
              <a:t>0. Osteoporo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13607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001" y="7667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62050" y="1533525"/>
            <a:ext cx="1157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1. GER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27062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2826" y="5921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85800" y="1724025"/>
            <a:ext cx="2717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2. Chronic live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8324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6901" y="51911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19200" y="1266825"/>
            <a:ext cx="1763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3. Malignancy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44476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4250" y="642937"/>
            <a:ext cx="7841455" cy="540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263299" y="1181100"/>
            <a:ext cx="1845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4. Lung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953283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1" y="873800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00125" y="1571625"/>
            <a:ext cx="22281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5. Stomach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296674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8526" y="7953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47725" y="1371600"/>
            <a:ext cx="2374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6. Colorectal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08607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6926" y="8080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19200" y="1352550"/>
            <a:ext cx="1811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7. Liver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33836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1069" y="706915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66775" y="1771650"/>
            <a:ext cx="2804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4. Use of </a:t>
            </a:r>
            <a:r>
              <a:rPr lang="en-US" altLang="ko-KR" dirty="0" err="1" smtClean="0"/>
              <a:t>Methylxanthin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3215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8326" y="604837"/>
            <a:ext cx="7841455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95375" y="1257300"/>
            <a:ext cx="2111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8. Thyroid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30659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9625" y="4492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09675" y="1828800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9. BMI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54804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0251" y="55086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52525" y="1514475"/>
            <a:ext cx="1863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0. Hemoglob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05489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90951" y="6429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47783" y="1924050"/>
            <a:ext cx="2876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1. Fasting blood gluco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25328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9476" y="862012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66800" y="1504950"/>
            <a:ext cx="2277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2. Total choleste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85364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0120" y="71913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28675" y="1590675"/>
            <a:ext cx="2369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3. Serum Creatinin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46413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4701" y="839787"/>
            <a:ext cx="7841455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85825" y="1409700"/>
            <a:ext cx="21771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4. Smoking statu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63490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7611" y="691423"/>
            <a:ext cx="7921760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85825" y="1466850"/>
            <a:ext cx="21643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5. Use of systemic </a:t>
            </a:r>
          </a:p>
          <a:p>
            <a:r>
              <a:rPr lang="en-US" altLang="ko-KR" dirty="0" smtClean="0"/>
              <a:t>beta agonist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49819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0173" y="970691"/>
            <a:ext cx="7921760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85875" y="1457325"/>
            <a:ext cx="153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6. Use of IC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485350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3171" y="998650"/>
            <a:ext cx="7921760" cy="540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57275" y="1333500"/>
            <a:ext cx="1675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7.Use of LAB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08330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</TotalTime>
  <Words>519</Words>
  <Application>Microsoft Office PowerPoint</Application>
  <PresentationFormat>와이드스크린</PresentationFormat>
  <Paragraphs>131</Paragraphs>
  <Slides>6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6</vt:i4>
      </vt:variant>
    </vt:vector>
  </HeadingPairs>
  <TitlesOfParts>
    <vt:vector size="70" baseType="lpstr">
      <vt:lpstr>맑은 고딕</vt:lpstr>
      <vt:lpstr>Arial</vt:lpstr>
      <vt:lpstr>Times New Roman</vt:lpstr>
      <vt:lpstr>Office 테마</vt:lpstr>
      <vt:lpstr>Kaplan-Meier Curves Comparing All-cause Mortalities in Entire Cohort According to Comorbidities and Clinical Variables</vt:lpstr>
      <vt:lpstr>List of Comorbidities and Clinical Variabl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Kaplan-Meier Curves Comparing All-cause Mortalities in Health-screening Cohort According to Comorbidities and  Clinical Variables</vt:lpstr>
      <vt:lpstr>List of Comorbidities and Clinical Variabl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OOM079_kimyejee33</dc:creator>
  <cp:lastModifiedBy>Windows 사용자</cp:lastModifiedBy>
  <cp:revision>29</cp:revision>
  <dcterms:created xsi:type="dcterms:W3CDTF">2019-07-10T07:11:46Z</dcterms:created>
  <dcterms:modified xsi:type="dcterms:W3CDTF">2020-01-19T05:37:08Z</dcterms:modified>
</cp:coreProperties>
</file>